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346" r:id="rId2"/>
    <p:sldId id="347" r:id="rId3"/>
    <p:sldId id="34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94"/>
  </p:normalViewPr>
  <p:slideViewPr>
    <p:cSldViewPr snapToGrid="0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A72182-EDFA-0770-10E1-14CF93833FB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2C04E92-F188-1306-C1C4-9DFDD51CEA2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88FDB0-CB7F-289B-1695-84DB709FBF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2F18C-AB41-BF4E-8550-7376BF5D37F1}" type="datetimeFigureOut">
              <a:rPr lang="en-US" smtClean="0"/>
              <a:t>12/2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851FE4-E79F-82A6-8330-2FB74AE66E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C596AF-5798-C0F4-FF6D-3700810228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1A8E2B-8403-394D-BE70-0745B0C073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44824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0D2E44-863B-7E53-07F5-78D0D060DE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E7D4212-A9AD-8001-F78A-EE2F669381F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0CE59F-023B-CCFC-EC9D-BF9FC977AC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2F18C-AB41-BF4E-8550-7376BF5D37F1}" type="datetimeFigureOut">
              <a:rPr lang="en-US" smtClean="0"/>
              <a:t>12/2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EF1B1A-1DE8-938C-05CD-716FC6D092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584259-0EE6-1EE2-25AF-0A45052635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1A8E2B-8403-394D-BE70-0745B0C073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32795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542C2A6-4767-DBF9-0BB1-F6C9C61154A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DACEB09-86BC-D120-61A2-8786ED56BC0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104734-FF60-70C3-54FA-67282EFD9A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2F18C-AB41-BF4E-8550-7376BF5D37F1}" type="datetimeFigureOut">
              <a:rPr lang="en-US" smtClean="0"/>
              <a:t>12/2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BB25A8-2CFA-635D-9C30-39C0580134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2B49AE-553D-F14A-CB97-775C617A4B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1A8E2B-8403-394D-BE70-0745B0C073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8136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D6DED0-1C03-DC60-3225-F75AA74F34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B42D399-75F5-DC4D-B8DC-D3B63536235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A18FB1-37B0-99E2-5461-79668DD2DE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2F18C-AB41-BF4E-8550-7376BF5D37F1}" type="datetimeFigureOut">
              <a:rPr lang="en-US" smtClean="0"/>
              <a:t>12/2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923ED2-7D26-7232-863E-336DDAB8EA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7C7FE3-375D-AA02-6366-4EB9D0A220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1A8E2B-8403-394D-BE70-0745B0C073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56685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2A61BA-B384-B095-BFDF-14AE3F142C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F7D8B0E-0CE0-85D0-C9B0-1D8D1CA8EE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E00382-8A34-B00C-6D49-E0A5BC3BF4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2F18C-AB41-BF4E-8550-7376BF5D37F1}" type="datetimeFigureOut">
              <a:rPr lang="en-US" smtClean="0"/>
              <a:t>12/2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CA0263-E798-9500-B853-9B31C65F53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5716E1-41B2-5731-0E46-D050DE4E83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1A8E2B-8403-394D-BE70-0745B0C073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65798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68F9D9-46FA-9822-80BA-35EE3FEE87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CC56965-05A3-6D2C-D98B-EAD1A21F040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3DD9FF3-22D8-77D2-9977-3C66E87DFF0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B64B67D-1FAF-5EA9-9199-5787ED04C8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2F18C-AB41-BF4E-8550-7376BF5D37F1}" type="datetimeFigureOut">
              <a:rPr lang="en-US" smtClean="0"/>
              <a:t>12/24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062389F-DCEF-68EA-E044-CDCDF0B3B9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F462D51-5A13-0108-3870-B3ADF9A66F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1A8E2B-8403-394D-BE70-0745B0C073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50390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82C0DC-FD4F-2F1A-B5EE-79190961E9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A795174-C7C7-B0D5-9520-E35A47DBA2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4BFC6F1-C27D-FFF6-B6C6-E15DC5D580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C44D0A8-1A03-B372-2C64-D35B41FC438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CC9CBB0-3509-5592-F5A8-59E5889E5FB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DBF9737-817B-C538-E1C9-4768DD47A9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2F18C-AB41-BF4E-8550-7376BF5D37F1}" type="datetimeFigureOut">
              <a:rPr lang="en-US" smtClean="0"/>
              <a:t>12/24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015BFCD-57C4-AEAF-218B-66BD873C1F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7FFF609-B44D-707F-85DE-A87CDB2F27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1A8E2B-8403-394D-BE70-0745B0C073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30322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D68C22-F734-B774-70CE-41B0451235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E7FF93B-935A-31FD-1338-BA3C53E8F3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2F18C-AB41-BF4E-8550-7376BF5D37F1}" type="datetimeFigureOut">
              <a:rPr lang="en-US" smtClean="0"/>
              <a:t>12/24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FB9ABC0-9F78-E916-3FFC-F5ACE6EB00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6651478-E409-3369-CE53-9A67A38A97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1A8E2B-8403-394D-BE70-0745B0C073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32055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8D12B1F-CE96-ED5D-BFE2-9B82AB92F5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2F18C-AB41-BF4E-8550-7376BF5D37F1}" type="datetimeFigureOut">
              <a:rPr lang="en-US" smtClean="0"/>
              <a:t>12/24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E6CF421-9629-61C5-66D6-162592AEE3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AB2A5CE-706C-42F6-D1FE-C014F8441C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1A8E2B-8403-394D-BE70-0745B0C073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10493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9A20CA-40D1-1756-934C-11E95C17F0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CA49FD0-4BF2-106F-44F6-1BD375094CE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D5F28C3-0600-7600-24AD-560AF745AAF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82A7E95-4E92-4C9E-F0C8-06FC9DE7E4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2F18C-AB41-BF4E-8550-7376BF5D37F1}" type="datetimeFigureOut">
              <a:rPr lang="en-US" smtClean="0"/>
              <a:t>12/24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2427D20-18D3-DBFD-611C-A58EEE0EF6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AAFF71B-BEC1-F0C9-5279-585364B673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1A8E2B-8403-394D-BE70-0745B0C073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04679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639935-D973-17A9-B1AF-77EEB9BF2C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495B9C2-243D-6527-C7C2-C917D2DA433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1F990E9-6A75-5DB5-A152-1411E9BF026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C378384-4485-D5CE-2C40-54E9B341CE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2F18C-AB41-BF4E-8550-7376BF5D37F1}" type="datetimeFigureOut">
              <a:rPr lang="en-US" smtClean="0"/>
              <a:t>12/24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EBC0CE8-AC3B-5F8E-65F7-4367B51BBF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3B4B5A9-02B7-81D5-3F72-FFE0527D75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1A8E2B-8403-394D-BE70-0745B0C073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72334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82C2E78-E642-27B1-E568-9219AD5BF2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B492663-DC26-A6F1-4D43-9ED1B639CB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6671F9-2C84-4E91-1C40-0B7D15FA473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0D2F18C-AB41-BF4E-8550-7376BF5D37F1}" type="datetimeFigureOut">
              <a:rPr lang="en-US" smtClean="0"/>
              <a:t>12/2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5F5528-4879-75AF-E039-962E2AC8E31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3BAD19-8D2F-4011-5D65-9EE7977D11F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11A8E2B-8403-394D-BE70-0745B0C073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80200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4A5DAB90-2C4C-0EB6-9A69-AE9928898F1C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08407" y="1153469"/>
            <a:ext cx="2229236" cy="1479833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AFCB1E1B-D433-BE9E-499D-39F5404F8B6C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254233" y="1110869"/>
            <a:ext cx="2276667" cy="1517779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F8A97BD-7383-5481-4B46-64729F1845C1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790200" y="1144838"/>
            <a:ext cx="2257694" cy="148931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8003EAD6-0C82-9734-3EAC-F686437105C3}"/>
              </a:ext>
            </a:extLst>
          </p:cNvPr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271395" y="1155740"/>
            <a:ext cx="2295639" cy="1479833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6C21BAF8-6755-2FDB-9BB7-1E29905D0CE9}"/>
              </a:ext>
            </a:extLst>
          </p:cNvPr>
          <p:cNvPicPr>
            <a:picLocks noChangeAspect="1"/>
          </p:cNvPicPr>
          <p:nvPr/>
        </p:nvPicPr>
        <p:blipFill>
          <a:blip r:embed="rId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14846" y="3206752"/>
            <a:ext cx="2219750" cy="1479833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3653EAAF-4107-3D43-F4DD-486507F7DDF6}"/>
              </a:ext>
            </a:extLst>
          </p:cNvPr>
          <p:cNvPicPr>
            <a:picLocks noChangeAspect="1"/>
          </p:cNvPicPr>
          <p:nvPr/>
        </p:nvPicPr>
        <p:blipFill>
          <a:blip r:embed="rId7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298617" y="3192522"/>
            <a:ext cx="2238722" cy="1508291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F38BB2AB-6452-4206-4EB4-C28B3D118374}"/>
              </a:ext>
            </a:extLst>
          </p:cNvPr>
          <p:cNvPicPr>
            <a:picLocks noChangeAspect="1"/>
          </p:cNvPicPr>
          <p:nvPr/>
        </p:nvPicPr>
        <p:blipFill>
          <a:blip r:embed="rId8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807752" y="3190563"/>
            <a:ext cx="2238722" cy="1498806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13BCD5FA-EA82-F2AA-3467-6AD6D134560F}"/>
              </a:ext>
            </a:extLst>
          </p:cNvPr>
          <p:cNvPicPr>
            <a:picLocks noChangeAspect="1"/>
          </p:cNvPicPr>
          <p:nvPr/>
        </p:nvPicPr>
        <p:blipFill>
          <a:blip r:embed="rId9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332950" y="3171591"/>
            <a:ext cx="2219750" cy="1517778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2B0BBECB-2CCE-F1F0-B2BC-44B74122B0D8}"/>
              </a:ext>
            </a:extLst>
          </p:cNvPr>
          <p:cNvSpPr txBox="1"/>
          <p:nvPr/>
        </p:nvSpPr>
        <p:spPr>
          <a:xfrm>
            <a:off x="1572491" y="743002"/>
            <a:ext cx="8906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0:00 am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5E7B7F6-DF07-4D4D-9767-C49B79D53973}"/>
              </a:ext>
            </a:extLst>
          </p:cNvPr>
          <p:cNvSpPr txBox="1"/>
          <p:nvPr/>
        </p:nvSpPr>
        <p:spPr>
          <a:xfrm>
            <a:off x="4229997" y="702495"/>
            <a:ext cx="8906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6:00 am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ABA5D32-B695-D1C8-0DC8-87FA7E59C2A1}"/>
              </a:ext>
            </a:extLst>
          </p:cNvPr>
          <p:cNvSpPr txBox="1"/>
          <p:nvPr/>
        </p:nvSpPr>
        <p:spPr>
          <a:xfrm>
            <a:off x="6551083" y="736824"/>
            <a:ext cx="8906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2:00 pm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6207362-633C-EF31-93FD-B7C4F0C7C419}"/>
              </a:ext>
            </a:extLst>
          </p:cNvPr>
          <p:cNvSpPr txBox="1"/>
          <p:nvPr/>
        </p:nvSpPr>
        <p:spPr>
          <a:xfrm>
            <a:off x="9025840" y="728133"/>
            <a:ext cx="8906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8:00 pm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93A6641-99C0-1B6F-14BA-CB7163C41D06}"/>
              </a:ext>
            </a:extLst>
          </p:cNvPr>
          <p:cNvSpPr txBox="1"/>
          <p:nvPr/>
        </p:nvSpPr>
        <p:spPr>
          <a:xfrm>
            <a:off x="551073" y="210687"/>
            <a:ext cx="32964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F269A20-7246-9917-7A82-38BB4B396195}"/>
              </a:ext>
            </a:extLst>
          </p:cNvPr>
          <p:cNvSpPr txBox="1"/>
          <p:nvPr/>
        </p:nvSpPr>
        <p:spPr>
          <a:xfrm>
            <a:off x="690660" y="4841671"/>
            <a:ext cx="10199079" cy="17211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50000"/>
              </a:lnSpc>
              <a:spcBef>
                <a:spcPts val="600"/>
              </a:spcBef>
              <a:spcAft>
                <a:spcPts val="600"/>
              </a:spcAft>
              <a:buNone/>
            </a:pP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. Feeding- versus fasting-phase simvastatin dosing differentially alters HDL across the light period</a:t>
            </a:r>
            <a:b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wenty-four–hour plasma lipid profiles in A/J mice treated with simvastatin for 5 weeks either mixed in chow during the active feeding phase (top panels) or by morning oral gavage during the light-phase fasting period (bottom panels). Plasma TC, HDL-C, UC, LDL-C, and TG were measured at 0:00, 6:00, 12:00, and 18:00 (n = 5 per group). Bars represent mean ± SEM; individual mice are shown as dots. Simvastatin given with food consistently shifted HDL-C downward relative to controls, whereas fasting-phase gavage shifted HDL-C upward at corresponding time points. Data are presented as mean ± SEM (n = 5 per group). Statistical significance was determined by one-way ANOVA: *p &lt; 0.05.</a:t>
            </a:r>
            <a:endParaRPr lang="en-US" sz="1200" dirty="0">
              <a:effectLst/>
              <a:latin typeface="Times New Roman" panose="0202060305040502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374791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70EFF384-C501-AE66-E1BD-A2CEDDBF1CF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17142" y="1563954"/>
            <a:ext cx="3352418" cy="203001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ABFD85B-00F1-5604-9609-E8BF3765C293}"/>
              </a:ext>
            </a:extLst>
          </p:cNvPr>
          <p:cNvSpPr txBox="1"/>
          <p:nvPr/>
        </p:nvSpPr>
        <p:spPr>
          <a:xfrm>
            <a:off x="4342340" y="603283"/>
            <a:ext cx="15860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2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BE3A73C-EDC4-771D-8280-2FED2633DC24}"/>
              </a:ext>
            </a:extLst>
          </p:cNvPr>
          <p:cNvSpPr txBox="1"/>
          <p:nvPr/>
        </p:nvSpPr>
        <p:spPr>
          <a:xfrm>
            <a:off x="1116923" y="3931422"/>
            <a:ext cx="10204219" cy="199817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50000"/>
              </a:lnSpc>
              <a:spcBef>
                <a:spcPts val="600"/>
              </a:spcBef>
              <a:spcAft>
                <a:spcPts val="600"/>
              </a:spcAft>
              <a:buNone/>
            </a:pP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2. Simvastatin exerts minimal effects on hepatic core clock gene expression in fasting and feeding states</a:t>
            </a:r>
            <a:b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patic mRNA expression of the core clock genes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mal1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200" i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rntl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and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er2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 A/J mice treated for 5 weeks with vehicle or simvastatin (~16 mg/kg/day). Simvastatin was administered either by oral gavage at ZT04 during the light-phase fasting period (Fasting + Veh, Fasting + Sima) or admixed into chow and consumed during the dark-phase feeding period (Feeding + Veh, Feeding + Sima), as in Figure 1. Livers were collected 5 h after the last gavage dose (ZT09) for the fasting regimen and 5 h after the main feeding bout (ZT05) for the dietary regimen. Gene expression was quantified by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PCR, normalized to </a:t>
            </a:r>
            <a:r>
              <a:rPr lang="en-US" sz="1200" i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prt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and expressed relative to the fasting-vehicle group. Data are mean ± SEM (n = 5 per group). Statistical significance, where present, is indicated by **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&lt; 0.001 (two-way ANOVA with Tukey’s post hoc test).</a:t>
            </a:r>
            <a:endParaRPr lang="en-US" sz="1200" dirty="0">
              <a:effectLst/>
              <a:latin typeface="Times New Roman" panose="0202060305040502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026263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8047146-C2E4-D540-DC3B-2F2593D557F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86CE3D42-A2C1-4631-C08F-A3A664E4C96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81946" y="1499507"/>
            <a:ext cx="3149600" cy="22479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228CC3DB-F87D-877C-5C7A-C22806C0DF3E}"/>
              </a:ext>
            </a:extLst>
          </p:cNvPr>
          <p:cNvSpPr txBox="1"/>
          <p:nvPr/>
        </p:nvSpPr>
        <p:spPr>
          <a:xfrm>
            <a:off x="4035110" y="545815"/>
            <a:ext cx="19024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3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AB5983E-C32E-082E-8C43-2F7C35BEBB1C}"/>
              </a:ext>
            </a:extLst>
          </p:cNvPr>
          <p:cNvSpPr txBox="1"/>
          <p:nvPr/>
        </p:nvSpPr>
        <p:spPr>
          <a:xfrm>
            <a:off x="1109710" y="4331767"/>
            <a:ext cx="10548256" cy="17211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50000"/>
              </a:lnSpc>
              <a:spcBef>
                <a:spcPts val="600"/>
              </a:spcBef>
              <a:spcAft>
                <a:spcPts val="600"/>
              </a:spcAft>
              <a:buNone/>
            </a:pP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3. PPARα antagonism blunts simvastatin-induced expression of HDL and glycerol-pathway genes in Huh7 cells</a:t>
            </a:r>
            <a:b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uh7 cells were treated with vehicle (Control), simvastatin, the selective PPARα antagonist GW6471, or simvastatin plus GW6471 under the conditions described in Methods. Relative mRNA levels of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POA1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LTP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HDL-related genes) and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PD1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K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glycerol-pathway genes) were measured by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PCR and normalized to housekeeping genes. Simvastatin alone markedly increased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POA1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LTP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PD1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and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K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whereas co-treatment with GW6471 largely abolished these transcriptional responses; GW6471 alone had minimal effects. Data are mean ± SEM, with individual data points (black circles) denoting independent biological replicates. Statistical significance is indicated as *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&lt; 0.01, **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&lt; 0.001 (two-way ANOVA with Tukey’s post hoc test).</a:t>
            </a:r>
            <a:endParaRPr lang="en-US" sz="1200" dirty="0">
              <a:effectLst/>
              <a:latin typeface="Times New Roman" panose="0202060305040502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280080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99</Words>
  <Application>Microsoft Macintosh PowerPoint</Application>
  <PresentationFormat>Widescreen</PresentationFormat>
  <Paragraphs>10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Zhang, Peixiang (Peter)</dc:creator>
  <cp:lastModifiedBy>Zhang, Peixiang (Peter)</cp:lastModifiedBy>
  <cp:revision>1</cp:revision>
  <dcterms:created xsi:type="dcterms:W3CDTF">2025-12-24T16:18:47Z</dcterms:created>
  <dcterms:modified xsi:type="dcterms:W3CDTF">2025-12-24T16:19:32Z</dcterms:modified>
</cp:coreProperties>
</file>